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pn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1"/>
  </p:notesMasterIdLst>
  <p:sldIdLst>
    <p:sldId id="273" r:id="rId5"/>
    <p:sldId id="272" r:id="rId6"/>
    <p:sldId id="278" r:id="rId7"/>
    <p:sldId id="275" r:id="rId8"/>
    <p:sldId id="276" r:id="rId9"/>
    <p:sldId id="274" r:id="rId10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3DC0305-9A8D-A41C-CD28-8B87569066BD}" name="Krebs, Simone S./Radiology" initials="KSS" userId="S::krebss@mskcc.org::abbc7251-8e67-4930-8f3e-5673c94fb719" providerId="AD"/>
  <p188:author id="{50FEAE0E-9317-C5FD-73AE-F2CB360713A9}" name="Eibler, Laura/Sloan Kettering Institute" initials="ELKI" userId="S::eiblerl@mskcc.org::7af5e0e0-f2ac-45e9-bac0-11d51b714464" providerId="AD"/>
  <p188:author id="{403DE23F-81A7-CF10-BA90-2C6C5983E47C}" name="Eibler, Laura/Sloan Kettering Institute" initials="ELKI" userId="S::EiblerL@mskcc.org::7af5e0e0-f2ac-45e9-bac0-11d51b714464" providerId="AD"/>
  <p188:author id="{195D2B7B-BD30-39D4-F6DE-FD0A6268B0BC}" name="Carter, Lukas" initials="CL" userId="S::carterl1@mskcc.org::ef23e0c7-938f-41c8-8c8e-49c758a8f982" providerId="AD"/>
  <p188:author id="{3EB6198D-E13F-5E06-C9BF-B7CFF96B8753}" name="Keifer Kurtz" initials="KK" userId="Keifer Kurtz" providerId="None"/>
  <p188:author id="{1A2FC4AF-2EAF-371C-DF22-31517821278B}" name="Stephanie Pierre" initials="SP" userId="S::sap4014@med.cornell.edu::df441f5a-d341-4ae1-901e-7fda8056a7bd" providerId="AD"/>
  <p188:author id="{D22759E0-0E14-250C-5E2D-1833439A5CAB}" name="Keifer Kurtz" initials="KK" userId="64545e0ce4b64839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D9D9E"/>
    <a:srgbClr val="3A6EB3"/>
    <a:srgbClr val="B21700"/>
    <a:srgbClr val="180000"/>
    <a:srgbClr val="13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2838BEF-8BB2-4498-84A7-C5851F593DF1}" styleName="Medium Style 4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8FD4443E-F989-4FC4-A0C8-D5A2AF1F390B}" styleName="Dark Style 1 - Accent 5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wholeTbl>
    <a:band1H>
      <a:tcStyle>
        <a:tcBdr/>
        <a:fill>
          <a:solidFill>
            <a:schemeClr val="accent5">
              <a:shade val="60000"/>
            </a:schemeClr>
          </a:solidFill>
        </a:fill>
      </a:tcStyle>
    </a:band1H>
    <a:band1V>
      <a:tcStyle>
        <a:tcBdr/>
        <a:fill>
          <a:solidFill>
            <a:schemeClr val="accent5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5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5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5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444" autoAdjust="0"/>
    <p:restoredTop sz="89048" autoAdjust="0"/>
  </p:normalViewPr>
  <p:slideViewPr>
    <p:cSldViewPr snapToGrid="0">
      <p:cViewPr>
        <p:scale>
          <a:sx n="80" d="100"/>
          <a:sy n="80" d="100"/>
        </p:scale>
        <p:origin x="2288" y="-456"/>
      </p:cViewPr>
      <p:guideLst>
        <p:guide orient="horz" pos="384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20" d="100"/>
        <a:sy n="2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microsoft.com/office/2018/10/relationships/authors" Target="author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88A87B-9014-4E7F-93DA-6A8B887562F5}" type="datetimeFigureOut">
              <a:rPr lang="en-US" smtClean="0"/>
              <a:t>2/24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60CC19-CB8C-458E-BB08-A389CC737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0943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60CC19-CB8C-458E-BB08-A389CC73719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3349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60CC19-CB8C-458E-BB08-A389CC73719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35193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60CC19-CB8C-458E-BB08-A389CC73719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69725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60CC19-CB8C-458E-BB08-A389CC73719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51034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20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60CC19-CB8C-458E-BB08-A389CC73719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10025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60CC19-CB8C-458E-BB08-A389CC73719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2129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CBC5D-3AD4-45CF-8013-65B1FC97E343}" type="datetimeFigureOut">
              <a:rPr lang="en-US" smtClean="0"/>
              <a:t>2/2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098C-2E5B-4872-84F6-27F2E14CC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047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CBC5D-3AD4-45CF-8013-65B1FC97E343}" type="datetimeFigureOut">
              <a:rPr lang="en-US" smtClean="0"/>
              <a:t>2/2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098C-2E5B-4872-84F6-27F2E14CC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373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CBC5D-3AD4-45CF-8013-65B1FC97E343}" type="datetimeFigureOut">
              <a:rPr lang="en-US" smtClean="0"/>
              <a:t>2/2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098C-2E5B-4872-84F6-27F2E14CC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144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CBC5D-3AD4-45CF-8013-65B1FC97E343}" type="datetimeFigureOut">
              <a:rPr lang="en-US" smtClean="0"/>
              <a:t>2/2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098C-2E5B-4872-84F6-27F2E14CC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039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CBC5D-3AD4-45CF-8013-65B1FC97E343}" type="datetimeFigureOut">
              <a:rPr lang="en-US" smtClean="0"/>
              <a:t>2/2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098C-2E5B-4872-84F6-27F2E14CC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76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CBC5D-3AD4-45CF-8013-65B1FC97E343}" type="datetimeFigureOut">
              <a:rPr lang="en-US" smtClean="0"/>
              <a:t>2/24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098C-2E5B-4872-84F6-27F2E14CC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638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CBC5D-3AD4-45CF-8013-65B1FC97E343}" type="datetimeFigureOut">
              <a:rPr lang="en-US" smtClean="0"/>
              <a:t>2/24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098C-2E5B-4872-84F6-27F2E14CC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3566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CBC5D-3AD4-45CF-8013-65B1FC97E343}" type="datetimeFigureOut">
              <a:rPr lang="en-US" smtClean="0"/>
              <a:t>2/24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098C-2E5B-4872-84F6-27F2E14CC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009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CBC5D-3AD4-45CF-8013-65B1FC97E343}" type="datetimeFigureOut">
              <a:rPr lang="en-US" smtClean="0"/>
              <a:t>2/24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098C-2E5B-4872-84F6-27F2E14CC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362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CBC5D-3AD4-45CF-8013-65B1FC97E343}" type="datetimeFigureOut">
              <a:rPr lang="en-US" smtClean="0"/>
              <a:t>2/24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098C-2E5B-4872-84F6-27F2E14CC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572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CBC5D-3AD4-45CF-8013-65B1FC97E343}" type="datetimeFigureOut">
              <a:rPr lang="en-US" smtClean="0"/>
              <a:t>2/24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098C-2E5B-4872-84F6-27F2E14CC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441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1CBC5D-3AD4-45CF-8013-65B1FC97E343}" type="datetimeFigureOut">
              <a:rPr lang="en-US" smtClean="0"/>
              <a:t>2/24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88098C-2E5B-4872-84F6-27F2E14CCA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695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7" Type="http://schemas.openxmlformats.org/officeDocument/2006/relationships/image" Target="../media/image10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1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5" name="Picture 1" descr="page1image31073856">
            <a:extLst>
              <a:ext uri="{FF2B5EF4-FFF2-40B4-BE49-F238E27FC236}">
                <a16:creationId xmlns:a16="http://schemas.microsoft.com/office/drawing/2014/main" id="{23A41FAE-5CD2-7943-8BC7-3359904643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5400" cy="43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40E1DDC-369C-3F4A-81AF-489C4CF41D2C}"/>
              </a:ext>
            </a:extLst>
          </p:cNvPr>
          <p:cNvSpPr txBox="1"/>
          <p:nvPr/>
        </p:nvSpPr>
        <p:spPr>
          <a:xfrm>
            <a:off x="25400" y="5287009"/>
            <a:ext cx="6513772" cy="141577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ry Figure 1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) Solid-phase ELISA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uSIR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⍺ was performed to determine binding isotherm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b’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B.) Solid-phase ELISA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uSIR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ᵧ was performed to determine binding  isotherm 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b’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C.) Solid-phase ELISA us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uSIRP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itchFamily="2" charset="2"/>
              </a:rPr>
              <a:t></a:t>
            </a:r>
            <a:r>
              <a:rPr lang="en-US" sz="1200" dirty="0">
                <a:effectLst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performed to determine binding  isotherm 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b’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/>
                <a:cs typeface="Arial"/>
              </a:rPr>
              <a:t> </a:t>
            </a:r>
            <a:endParaRPr lang="en-US" sz="1200" dirty="0">
              <a:latin typeface="Arial"/>
              <a:cs typeface="Arial"/>
            </a:endParaRPr>
          </a:p>
          <a:p>
            <a:endParaRPr lang="en-US" sz="1200" dirty="0">
              <a:latin typeface="Arial"/>
              <a:cs typeface="Arial"/>
            </a:endParaRPr>
          </a:p>
          <a:p>
            <a:b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6DB2BA-2D8B-404B-ABAB-D2FFE9A64779}"/>
              </a:ext>
            </a:extLst>
          </p:cNvPr>
          <p:cNvSpPr txBox="1"/>
          <p:nvPr/>
        </p:nvSpPr>
        <p:spPr>
          <a:xfrm>
            <a:off x="158505" y="308922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F502959-6BF5-8948-9905-769CC73B94B4}"/>
              </a:ext>
            </a:extLst>
          </p:cNvPr>
          <p:cNvSpPr txBox="1"/>
          <p:nvPr/>
        </p:nvSpPr>
        <p:spPr>
          <a:xfrm>
            <a:off x="3361821" y="303113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611E91F-AAD4-EC43-B631-35C548649C16}"/>
              </a:ext>
            </a:extLst>
          </p:cNvPr>
          <p:cNvSpPr txBox="1"/>
          <p:nvPr/>
        </p:nvSpPr>
        <p:spPr>
          <a:xfrm>
            <a:off x="1160068" y="2779788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0ADBE138-3DB0-B444-A2E4-3102BB03D1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8505" y="672445"/>
            <a:ext cx="2816352" cy="1929541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3B8AF38-0542-064B-847F-1E8BBF935D0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48869" y="664324"/>
            <a:ext cx="3556983" cy="192954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9C81C3B-2D87-F64F-83DB-FCB3956F681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19451" y="3123437"/>
            <a:ext cx="3657600" cy="19841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21483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5" name="Picture 1" descr="page1image31073856">
            <a:extLst>
              <a:ext uri="{FF2B5EF4-FFF2-40B4-BE49-F238E27FC236}">
                <a16:creationId xmlns:a16="http://schemas.microsoft.com/office/drawing/2014/main" id="{23A41FAE-5CD2-7943-8BC7-3359904643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5400" cy="43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40E1DDC-369C-3F4A-81AF-489C4CF41D2C}"/>
              </a:ext>
            </a:extLst>
          </p:cNvPr>
          <p:cNvSpPr txBox="1"/>
          <p:nvPr/>
        </p:nvSpPr>
        <p:spPr>
          <a:xfrm>
            <a:off x="25400" y="6155193"/>
            <a:ext cx="6513772" cy="138499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ry Figure 2. </a:t>
            </a:r>
            <a:r>
              <a:rPr lang="en-US" sz="1200" dirty="0">
                <a:latin typeface="Arial"/>
                <a:cs typeface="Arial"/>
              </a:rPr>
              <a:t>A.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olid-phase ELISA using mouse SIRP⍺ was performed to determine binding capacity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b’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B.) Solid-phase ELISA using cynomolgus SIRP ⍺ was performed to determine binding capacity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b’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/>
              <a:cs typeface="Arial"/>
            </a:endParaRPr>
          </a:p>
          <a:p>
            <a:endParaRPr lang="en-US" sz="1200" dirty="0">
              <a:latin typeface="Arial"/>
              <a:cs typeface="Arial"/>
            </a:endParaRPr>
          </a:p>
          <a:p>
            <a:endParaRPr lang="en-US" sz="1200" dirty="0">
              <a:latin typeface="Arial"/>
              <a:cs typeface="Arial"/>
            </a:endParaRPr>
          </a:p>
          <a:p>
            <a:b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D8105DB-651A-774C-84D3-52293C9345A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55834" y="995331"/>
            <a:ext cx="3251200" cy="225898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A4D958D-9D83-5B4C-BBF1-D34B8D80292A}"/>
              </a:ext>
            </a:extLst>
          </p:cNvPr>
          <p:cNvSpPr txBox="1"/>
          <p:nvPr/>
        </p:nvSpPr>
        <p:spPr>
          <a:xfrm>
            <a:off x="1102468" y="810665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80C0A35-D84B-064E-AF26-2A57C6184931}"/>
              </a:ext>
            </a:extLst>
          </p:cNvPr>
          <p:cNvSpPr txBox="1"/>
          <p:nvPr/>
        </p:nvSpPr>
        <p:spPr>
          <a:xfrm>
            <a:off x="1102468" y="3612433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847442F-B44F-D24B-8A9A-46A8241C26A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47945" y="3745653"/>
            <a:ext cx="3504452" cy="23149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38858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BCC5ED7-ECD7-2497-65DA-188E50008DD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841" y="6273517"/>
            <a:ext cx="6161167" cy="2870993"/>
          </a:xfrm>
          <a:prstGeom prst="rect">
            <a:avLst/>
          </a:prstGeom>
        </p:spPr>
      </p:pic>
      <p:pic>
        <p:nvPicPr>
          <p:cNvPr id="6145" name="Picture 1" descr="page1image31073856">
            <a:extLst>
              <a:ext uri="{FF2B5EF4-FFF2-40B4-BE49-F238E27FC236}">
                <a16:creationId xmlns:a16="http://schemas.microsoft.com/office/drawing/2014/main" id="{23A41FAE-5CD2-7943-8BC7-3359904643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5400" cy="43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40E1DDC-369C-3F4A-81AF-489C4CF41D2C}"/>
              </a:ext>
            </a:extLst>
          </p:cNvPr>
          <p:cNvSpPr txBox="1"/>
          <p:nvPr/>
        </p:nvSpPr>
        <p:spPr>
          <a:xfrm>
            <a:off x="217228" y="9354736"/>
            <a:ext cx="6513772" cy="120032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ry Figure 3. </a:t>
            </a:r>
            <a:r>
              <a:rPr lang="en-US" sz="1200" dirty="0">
                <a:latin typeface="Arial"/>
                <a:cs typeface="Arial"/>
              </a:rPr>
              <a:t>A.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ating strategy utilized for T-cell activation comparison for 1H9 and F05 activity. Geometric mean of MFI of CD25 (B), CD69 (C), or Ki67 (D) on CD3+,CD45+ PBMCs grown in IL-2 and also treated with either F05, 1H9, or no antibody (n=2). E.) Gating strategy utilized for T-cell inhibition comparison for 1H9 and F05. Geometric mean of MFI of CD25 (F), CD69 (G), or Ki67 (H) on CD2+,CD45+ PBMCs activated with IL-2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cul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also either with F05, 1H9, or no antibody (n=2)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A4D958D-9D83-5B4C-BBF1-D34B8D80292A}"/>
              </a:ext>
            </a:extLst>
          </p:cNvPr>
          <p:cNvSpPr txBox="1"/>
          <p:nvPr/>
        </p:nvSpPr>
        <p:spPr>
          <a:xfrm>
            <a:off x="12700" y="0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80C0A35-D84B-064E-AF26-2A57C6184931}"/>
              </a:ext>
            </a:extLst>
          </p:cNvPr>
          <p:cNvSpPr txBox="1"/>
          <p:nvPr/>
        </p:nvSpPr>
        <p:spPr>
          <a:xfrm>
            <a:off x="411762" y="1903793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" name="Picture 3" descr="A comparison of a blue and black object&#10;&#10;Description automatically generated with medium confidence">
            <a:extLst>
              <a:ext uri="{FF2B5EF4-FFF2-40B4-BE49-F238E27FC236}">
                <a16:creationId xmlns:a16="http://schemas.microsoft.com/office/drawing/2014/main" id="{5345A1DE-40C5-144A-ADEE-9BEA6480E2F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8575" y="369332"/>
            <a:ext cx="6858000" cy="164515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2458115-445D-4AA6-BBB9-C83DED35F3C3}"/>
              </a:ext>
            </a:extLst>
          </p:cNvPr>
          <p:cNvSpPr txBox="1"/>
          <p:nvPr/>
        </p:nvSpPr>
        <p:spPr>
          <a:xfrm>
            <a:off x="2382232" y="1899914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5ECFA55-EE40-DCB6-FF1D-9478DA5BC7B1}"/>
              </a:ext>
            </a:extLst>
          </p:cNvPr>
          <p:cNvSpPr txBox="1"/>
          <p:nvPr/>
        </p:nvSpPr>
        <p:spPr>
          <a:xfrm>
            <a:off x="4453779" y="1890718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6" name="Picture 15" descr="A diagram of a pointy cone&#10;&#10;Description automatically generated with medium confidence">
            <a:extLst>
              <a:ext uri="{FF2B5EF4-FFF2-40B4-BE49-F238E27FC236}">
                <a16:creationId xmlns:a16="http://schemas.microsoft.com/office/drawing/2014/main" id="{1BFD67B2-6704-2C40-6B56-52DF2FE949F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00" y="4601069"/>
            <a:ext cx="6858000" cy="164515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E7E3B5F-D291-2697-C7C9-DF0274B3D8FB}"/>
              </a:ext>
            </a:extLst>
          </p:cNvPr>
          <p:cNvSpPr txBox="1"/>
          <p:nvPr/>
        </p:nvSpPr>
        <p:spPr>
          <a:xfrm>
            <a:off x="-36138" y="4283231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E880B4E-CA03-1E84-09E8-24847F3CD641}"/>
              </a:ext>
            </a:extLst>
          </p:cNvPr>
          <p:cNvSpPr txBox="1"/>
          <p:nvPr/>
        </p:nvSpPr>
        <p:spPr>
          <a:xfrm>
            <a:off x="411762" y="6343478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1005F72-192F-0303-F79E-B3A21ED70A7C}"/>
              </a:ext>
            </a:extLst>
          </p:cNvPr>
          <p:cNvSpPr txBox="1"/>
          <p:nvPr/>
        </p:nvSpPr>
        <p:spPr>
          <a:xfrm>
            <a:off x="2382232" y="6379396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C402EED-0FF6-9CC4-D892-CC8B4AA3008A}"/>
              </a:ext>
            </a:extLst>
          </p:cNvPr>
          <p:cNvSpPr txBox="1"/>
          <p:nvPr/>
        </p:nvSpPr>
        <p:spPr>
          <a:xfrm>
            <a:off x="4453779" y="6379396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9E43A74-F2BD-75B0-4F40-636FF8A1A55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979" y="1916960"/>
            <a:ext cx="6023576" cy="2694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54516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5" name="Picture 1" descr="page1image31073856">
            <a:extLst>
              <a:ext uri="{FF2B5EF4-FFF2-40B4-BE49-F238E27FC236}">
                <a16:creationId xmlns:a16="http://schemas.microsoft.com/office/drawing/2014/main" id="{23A41FAE-5CD2-7943-8BC7-3359904643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5400" cy="43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40E1DDC-369C-3F4A-81AF-489C4CF41D2C}"/>
              </a:ext>
            </a:extLst>
          </p:cNvPr>
          <p:cNvSpPr txBox="1"/>
          <p:nvPr/>
        </p:nvSpPr>
        <p:spPr>
          <a:xfrm>
            <a:off x="48368" y="10251793"/>
            <a:ext cx="6513772" cy="138499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ry Figure 4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inding of Raji-GFP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ireflyLuciferas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A) or MUC16+ Skov3-mcherry-Gaussia Luciferase (B) cells to a commercially available anti-SIRP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tibody (clone 15-414).  Blue =I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otyp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ontrol, red=SIRP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tibody.  Binding of CD47 antibody to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Jurka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C), Raji-GFP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ireflyLuciferas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D), MUC16+ Skov3-mcherry-Gaussia Luciferase (E), and THP1 (F) cells.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Red = isotyp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rol and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orange = CD47 antibody.</a:t>
            </a:r>
            <a:endParaRPr lang="en-US" sz="1200" dirty="0">
              <a:latin typeface="Arial"/>
              <a:cs typeface="Arial"/>
            </a:endParaRPr>
          </a:p>
          <a:p>
            <a:b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A4D958D-9D83-5B4C-BBF1-D34B8D80292A}"/>
              </a:ext>
            </a:extLst>
          </p:cNvPr>
          <p:cNvSpPr txBox="1"/>
          <p:nvPr/>
        </p:nvSpPr>
        <p:spPr>
          <a:xfrm>
            <a:off x="657968" y="1432375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80C0A35-D84B-064E-AF26-2A57C6184931}"/>
              </a:ext>
            </a:extLst>
          </p:cNvPr>
          <p:cNvSpPr txBox="1"/>
          <p:nvPr/>
        </p:nvSpPr>
        <p:spPr>
          <a:xfrm>
            <a:off x="3712742" y="1432375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0" name="Picture 39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40AEB5BC-B146-3D57-F3C5-32C9A1B4FBC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354" b="10504"/>
          <a:stretch/>
        </p:blipFill>
        <p:spPr>
          <a:xfrm>
            <a:off x="3056466" y="1801707"/>
            <a:ext cx="4038600" cy="2993813"/>
          </a:xfrm>
          <a:prstGeom prst="rect">
            <a:avLst/>
          </a:prstGeom>
        </p:spPr>
      </p:pic>
      <p:pic>
        <p:nvPicPr>
          <p:cNvPr id="42" name="Picture 41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DB6838A6-B5DE-D497-9F8B-7ECA47DA758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988" r="8906" b="18507"/>
          <a:stretch/>
        </p:blipFill>
        <p:spPr>
          <a:xfrm>
            <a:off x="48368" y="1711703"/>
            <a:ext cx="3431563" cy="299381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F17B7F3-3068-EE19-07C3-28B525A24E1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0836" y="4995309"/>
            <a:ext cx="6135194" cy="516647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B036077-4E80-2DC8-A304-9C3173243DC0}"/>
              </a:ext>
            </a:extLst>
          </p:cNvPr>
          <p:cNvSpPr txBox="1"/>
          <p:nvPr/>
        </p:nvSpPr>
        <p:spPr>
          <a:xfrm>
            <a:off x="328604" y="4625977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AE1C118-925E-AF46-3949-B9438E134431}"/>
              </a:ext>
            </a:extLst>
          </p:cNvPr>
          <p:cNvSpPr txBox="1"/>
          <p:nvPr/>
        </p:nvSpPr>
        <p:spPr>
          <a:xfrm>
            <a:off x="3966108" y="4625977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978B9E3-8DC9-579B-C746-4959534E64BA}"/>
              </a:ext>
            </a:extLst>
          </p:cNvPr>
          <p:cNvSpPr txBox="1"/>
          <p:nvPr/>
        </p:nvSpPr>
        <p:spPr>
          <a:xfrm>
            <a:off x="348127" y="7258874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62D9426-8411-877A-059C-85326C1A7CF3}"/>
              </a:ext>
            </a:extLst>
          </p:cNvPr>
          <p:cNvSpPr txBox="1"/>
          <p:nvPr/>
        </p:nvSpPr>
        <p:spPr>
          <a:xfrm>
            <a:off x="3985631" y="7258874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0721795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5" name="Picture 1" descr="page1image31073856">
            <a:extLst>
              <a:ext uri="{FF2B5EF4-FFF2-40B4-BE49-F238E27FC236}">
                <a16:creationId xmlns:a16="http://schemas.microsoft.com/office/drawing/2014/main" id="{23A41FAE-5CD2-7943-8BC7-3359904643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5400" cy="43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40E1DDC-369C-3F4A-81AF-489C4CF41D2C}"/>
              </a:ext>
            </a:extLst>
          </p:cNvPr>
          <p:cNvSpPr txBox="1"/>
          <p:nvPr/>
        </p:nvSpPr>
        <p:spPr>
          <a:xfrm>
            <a:off x="172114" y="8707262"/>
            <a:ext cx="6513772" cy="101566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ry Figure 5. </a:t>
            </a:r>
            <a:r>
              <a:rPr lang="en-US" sz="1200" dirty="0">
                <a:latin typeface="Arial"/>
                <a:cs typeface="Arial"/>
              </a:rPr>
              <a:t>A.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ating Strategy utilized for flow cytometry experiments performed in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Figure 5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 to E.) Raw Histogram data for the 3 donors used in Figure 3C-F. Grey=untreated, red=RITUX, green=1H9, blue=F05. D=donor</a:t>
            </a:r>
            <a:endParaRPr lang="en-US" sz="1200" dirty="0">
              <a:latin typeface="Arial"/>
              <a:cs typeface="Arial"/>
            </a:endParaRPr>
          </a:p>
          <a:p>
            <a:b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A4D958D-9D83-5B4C-BBF1-D34B8D80292A}"/>
              </a:ext>
            </a:extLst>
          </p:cNvPr>
          <p:cNvSpPr txBox="1"/>
          <p:nvPr/>
        </p:nvSpPr>
        <p:spPr>
          <a:xfrm>
            <a:off x="48368" y="1069673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80C0A35-D84B-064E-AF26-2A57C6184931}"/>
              </a:ext>
            </a:extLst>
          </p:cNvPr>
          <p:cNvSpPr txBox="1"/>
          <p:nvPr/>
        </p:nvSpPr>
        <p:spPr>
          <a:xfrm>
            <a:off x="283520" y="3086860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A0AE4D9-E97B-12EF-3E3F-25C42C86DD7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368" y="1439005"/>
            <a:ext cx="6761264" cy="157413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4C2FB14F-C709-1E5E-CDB5-D2F160065AA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4568" y="3484738"/>
            <a:ext cx="6685064" cy="1629446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398DD269-EC25-4518-4711-0508AB5D358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4568" y="5066391"/>
            <a:ext cx="6685064" cy="1627937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BABE816A-62A8-866D-AFD4-88946EB6B3A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4568" y="6688120"/>
            <a:ext cx="6685064" cy="177321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442C960-5222-3FD4-B4D1-6FF7E8202948}"/>
              </a:ext>
            </a:extLst>
          </p:cNvPr>
          <p:cNvSpPr txBox="1"/>
          <p:nvPr/>
        </p:nvSpPr>
        <p:spPr>
          <a:xfrm>
            <a:off x="1891682" y="3086860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35ED545-5BE3-4FFB-612D-5B98161B8390}"/>
              </a:ext>
            </a:extLst>
          </p:cNvPr>
          <p:cNvSpPr txBox="1"/>
          <p:nvPr/>
        </p:nvSpPr>
        <p:spPr>
          <a:xfrm>
            <a:off x="3589854" y="3086860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06E39C5-43F3-B2F4-AD6F-91A564893895}"/>
              </a:ext>
            </a:extLst>
          </p:cNvPr>
          <p:cNvSpPr txBox="1"/>
          <p:nvPr/>
        </p:nvSpPr>
        <p:spPr>
          <a:xfrm>
            <a:off x="5288026" y="3086860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AA23A91-FF1B-C407-59BF-6F9D1A3F924E}"/>
              </a:ext>
            </a:extLst>
          </p:cNvPr>
          <p:cNvSpPr txBox="1"/>
          <p:nvPr/>
        </p:nvSpPr>
        <p:spPr>
          <a:xfrm>
            <a:off x="-3124" y="3855097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80877CF-112E-E98A-283D-74930AC56812}"/>
              </a:ext>
            </a:extLst>
          </p:cNvPr>
          <p:cNvSpPr txBox="1"/>
          <p:nvPr/>
        </p:nvSpPr>
        <p:spPr>
          <a:xfrm>
            <a:off x="-3124" y="5479805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001CE3A-83F2-25A7-7F0C-0E687A170022}"/>
              </a:ext>
            </a:extLst>
          </p:cNvPr>
          <p:cNvSpPr txBox="1"/>
          <p:nvPr/>
        </p:nvSpPr>
        <p:spPr>
          <a:xfrm>
            <a:off x="-3124" y="7104513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3</a:t>
            </a:r>
          </a:p>
        </p:txBody>
      </p:sp>
    </p:spTree>
    <p:extLst>
      <p:ext uri="{BB962C8B-B14F-4D97-AF65-F5344CB8AC3E}">
        <p14:creationId xmlns:p14="http://schemas.microsoft.com/office/powerpoint/2010/main" val="36231660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5" name="Picture 1" descr="page1image31073856">
            <a:extLst>
              <a:ext uri="{FF2B5EF4-FFF2-40B4-BE49-F238E27FC236}">
                <a16:creationId xmlns:a16="http://schemas.microsoft.com/office/drawing/2014/main" id="{23A41FAE-5CD2-7943-8BC7-3359904643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5400" cy="43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6EF2FCCF-AC1B-796C-0C35-5CD45ABC7620}"/>
              </a:ext>
            </a:extLst>
          </p:cNvPr>
          <p:cNvSpPr txBox="1"/>
          <p:nvPr/>
        </p:nvSpPr>
        <p:spPr>
          <a:xfrm>
            <a:off x="1552334" y="111791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E4D65ED-AACE-5687-47BD-C259DAE0C7EB}"/>
              </a:ext>
            </a:extLst>
          </p:cNvPr>
          <p:cNvSpPr txBox="1"/>
          <p:nvPr/>
        </p:nvSpPr>
        <p:spPr>
          <a:xfrm>
            <a:off x="376185" y="2232725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40E1DDC-369C-3F4A-81AF-489C4CF41D2C}"/>
              </a:ext>
            </a:extLst>
          </p:cNvPr>
          <p:cNvSpPr txBox="1"/>
          <p:nvPr/>
        </p:nvSpPr>
        <p:spPr>
          <a:xfrm>
            <a:off x="172114" y="4403552"/>
            <a:ext cx="6513772" cy="156966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ry Figure 6</a:t>
            </a:r>
            <a:r>
              <a:rPr lang="en-US" sz="1200" dirty="0">
                <a:latin typeface="Arial"/>
                <a:cs typeface="Arial"/>
              </a:rPr>
              <a:t>. A.) Scheme. A mixture of Raji tumor cells (2x10</a:t>
            </a:r>
            <a:r>
              <a:rPr lang="en-US" sz="1200" baseline="30000" dirty="0">
                <a:latin typeface="Arial"/>
                <a:cs typeface="Arial"/>
              </a:rPr>
              <a:t>6</a:t>
            </a:r>
            <a:r>
              <a:rPr lang="en-US" sz="1200" dirty="0">
                <a:latin typeface="Arial"/>
                <a:cs typeface="Arial"/>
              </a:rPr>
              <a:t>) and human M2 macrophages (1x10</a:t>
            </a:r>
            <a:r>
              <a:rPr lang="en-US" sz="1200" baseline="30000" dirty="0">
                <a:latin typeface="Arial"/>
                <a:cs typeface="Arial"/>
              </a:rPr>
              <a:t>5</a:t>
            </a:r>
            <a:r>
              <a:rPr lang="en-US" sz="1200" dirty="0">
                <a:latin typeface="Arial"/>
                <a:cs typeface="Arial"/>
              </a:rPr>
              <a:t>) were injected on D0 and </a:t>
            </a:r>
            <a:r>
              <a:rPr lang="en-US" sz="1200" dirty="0" err="1">
                <a:latin typeface="Arial"/>
                <a:cs typeface="Arial"/>
              </a:rPr>
              <a:t>mAb</a:t>
            </a:r>
            <a:r>
              <a:rPr lang="en-US" sz="1200" dirty="0">
                <a:latin typeface="Arial"/>
                <a:cs typeface="Arial"/>
              </a:rPr>
              <a:t> therapy was started on D11 post tumor injection and performed every 4 days for a total of 6 doses. B.) Tumors as measured by calipers overtime. C.) Survival curve analysis </a:t>
            </a:r>
            <a:r>
              <a:rPr lang="en-US" sz="1200">
                <a:latin typeface="Arial"/>
                <a:cs typeface="Arial"/>
              </a:rPr>
              <a:t>of (A-B). </a:t>
            </a:r>
            <a:r>
              <a:rPr lang="en-US" sz="1200" dirty="0">
                <a:latin typeface="Arial"/>
                <a:cs typeface="Arial"/>
              </a:rPr>
              <a:t>Control group mice with PBS or Rituximab were sacrificed due to tumor size and treatment group mice were sacrificed for surrogate death endpoints. (F05 vs RITUX, p = 0.13; 1H9 vs RITUX, p =0.29)</a:t>
            </a:r>
          </a:p>
          <a:p>
            <a:b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C9E9568-2DD8-864B-A195-1BC5D21AB52B}"/>
              </a:ext>
            </a:extLst>
          </p:cNvPr>
          <p:cNvSpPr txBox="1"/>
          <p:nvPr/>
        </p:nvSpPr>
        <p:spPr>
          <a:xfrm>
            <a:off x="3601035" y="2227533"/>
            <a:ext cx="506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5DD63EB8-D94E-954D-ADFA-65528273621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4" t="13848" r="23233" b="23594"/>
          <a:stretch/>
        </p:blipFill>
        <p:spPr>
          <a:xfrm>
            <a:off x="1917052" y="341214"/>
            <a:ext cx="2737145" cy="1664647"/>
          </a:xfrm>
          <a:prstGeom prst="rect">
            <a:avLst/>
          </a:prstGeom>
        </p:spPr>
      </p:pic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0B708EE-ABB0-31E2-8B65-9164A8228D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740663"/>
              </p:ext>
            </p:extLst>
          </p:nvPr>
        </p:nvGraphicFramePr>
        <p:xfrm>
          <a:off x="172114" y="2539556"/>
          <a:ext cx="6623050" cy="1916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6622896" imgH="1915811" progId="Prism10.Document">
                  <p:embed/>
                </p:oleObj>
              </mc:Choice>
              <mc:Fallback>
                <p:oleObj name="Prism 10" r:id="rId5" imgW="6622896" imgH="191581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2114" y="2539556"/>
                        <a:ext cx="6623050" cy="1916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23492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f65bd33f-4642-4d95-937d-1ab46361a753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B0306E0E11EAA4DB461FC8B09FCE607" ma:contentTypeVersion="14" ma:contentTypeDescription="Create a new document." ma:contentTypeScope="" ma:versionID="91d72963052586f58f72dae22b03a927">
  <xsd:schema xmlns:xsd="http://www.w3.org/2001/XMLSchema" xmlns:xs="http://www.w3.org/2001/XMLSchema" xmlns:p="http://schemas.microsoft.com/office/2006/metadata/properties" xmlns:ns3="f5de9215-86bc-4059-b445-233b46b31a63" xmlns:ns4="f65bd33f-4642-4d95-937d-1ab46361a753" targetNamespace="http://schemas.microsoft.com/office/2006/metadata/properties" ma:root="true" ma:fieldsID="fadba82acd4192bc94c99d14abebe8c2" ns3:_="" ns4:_="">
    <xsd:import namespace="f5de9215-86bc-4059-b445-233b46b31a63"/>
    <xsd:import namespace="f65bd33f-4642-4d95-937d-1ab46361a753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AutoKeyPoints" minOccurs="0"/>
                <xsd:element ref="ns4:MediaServiceKeyPoints" minOccurs="0"/>
                <xsd:element ref="ns4:MediaLengthInSeconds" minOccurs="0"/>
                <xsd:element ref="ns4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5de9215-86bc-4059-b445-233b46b31a63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65bd33f-4642-4d95-937d-1ab46361a75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D856636-5343-4257-B1FB-C325997F568E}">
  <ds:schemaRefs>
    <ds:schemaRef ds:uri="http://www.w3.org/XML/1998/namespace"/>
    <ds:schemaRef ds:uri="http://purl.org/dc/elements/1.1/"/>
    <ds:schemaRef ds:uri="http://purl.org/dc/dcmitype/"/>
    <ds:schemaRef ds:uri="http://schemas.microsoft.com/office/2006/documentManagement/types"/>
    <ds:schemaRef ds:uri="http://schemas.microsoft.com/office/infopath/2007/PartnerControls"/>
    <ds:schemaRef ds:uri="f65bd33f-4642-4d95-937d-1ab46361a753"/>
    <ds:schemaRef ds:uri="http://schemas.microsoft.com/office/2006/metadata/properties"/>
    <ds:schemaRef ds:uri="http://schemas.openxmlformats.org/package/2006/metadata/core-properties"/>
    <ds:schemaRef ds:uri="f5de9215-86bc-4059-b445-233b46b31a63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3EC30852-46A0-4053-BBE0-F3201A9182F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5de9215-86bc-4059-b445-233b46b31a63"/>
    <ds:schemaRef ds:uri="f65bd33f-4642-4d95-937d-1ab46361a75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1FAAFB9B-61F5-4C23-9DC2-E16EBA51494E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9173</TotalTime>
  <Words>495</Words>
  <Application>Microsoft Macintosh PowerPoint</Application>
  <PresentationFormat>Widescreen</PresentationFormat>
  <Paragraphs>50</Paragraphs>
  <Slides>6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ibler, Laura/Sloan Kettering Institute</dc:creator>
  <cp:lastModifiedBy>Scheinberg, David</cp:lastModifiedBy>
  <cp:revision>328</cp:revision>
  <dcterms:created xsi:type="dcterms:W3CDTF">2022-06-21T16:25:39Z</dcterms:created>
  <dcterms:modified xsi:type="dcterms:W3CDTF">2025-02-24T15:33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B0306E0E11EAA4DB461FC8B09FCE607</vt:lpwstr>
  </property>
</Properties>
</file>